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ink/ink16.xml" ContentType="application/inkml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03"/>
  </p:normalViewPr>
  <p:slideViewPr>
    <p:cSldViewPr snapToGrid="0">
      <p:cViewPr varScale="1">
        <p:scale>
          <a:sx n="109" d="100"/>
          <a:sy n="109" d="100"/>
        </p:scale>
        <p:origin x="6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4:46.75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1 24575,'20'63'0,"-15"-41"0,18 38 0,-15-47 0,-3-8 0,5 5 0,-9-3 0,5-6 0,-5 5 0,6-5 0,-7 6 0,7-3 0,-6 3 0,5 0 0,-5 1 0,5-4 0,-5 2 0,6-2 0,-3 3 0,0 1 0,3-4 0,-7 2 0,4-1 0,-1-1 0,-2 3 0,3-3 0,-1 0 0,-2 3 0,6-3 0,-7 4 0,7-1 0,-6 1 0,6-4 0,-6 2 0,5-2 0,-5 4 0,6-4 0,-6 2 0,5-5 0,-5 6 0,2-3 0,1 0 0,-4 3 0,4-3 0,-1 0 0,-2 3 0,5-6 0,-5 5 0,5-5 0,-5 5 0,2-2 0,0 0 0,-2-1 0,2-3 0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46.64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1 24575,'0'7'0,"0"0"0,3 0 0,1 1 0,0-1 0,3 1 0,-6-1 0,5 1 0,-5-1 0,6-2 0,-7 1 0,4-1 0,-1 2 0,-2 1 0,6 0 0,-6-1 0,6 1 0,-7-1 0,7 0 0,-6 1 0,5-4 0,-5 3 0,6-3 0,-6 4 0,5-4 0,-5 2 0,3-1 0,-1-1 0,-2 3 0,6-6 0,-6 5 0,5-2 0,-5 4 0,6-4 0,-6 3 0,5-3 0,-2 3 0,0 1 0,0-1 0,-1-3 0,-2 3 0,2-3 0,1 0 0,-3 2 0,5-2 0,-5 3 0,5-3 0,-5 3 0,2-3 0,-3 3 0,4-3 0,-3 2 0,2-2 0,1 0 0,-4 2 0,4-2 0,-1 0 0,-2 3 0,2-3 0,0 0 0,-2 2 0,6-5 0,-7 5 0,4-2 0,-4 3 0,0 0 0,3-3 0,-2 2 0,2-5 0,-3 2 0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17.194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1462 24575,'8'0'0,"-1"0"0,5 0 0,-4 0 0,4 0 0,-4 0 0,-1-3 0,1 2 0,4-3 0,-3 1 0,3-1 0,-1-1 0,-2-2 0,7 3 0,-7-4 0,7 0 0,-3-1 0,4-3 0,5 2 0,-4-6 0,9 6 0,-4-7 0,5 2 0,6 0 0,-4-3 0,4 8 0,-6-8 0,0 3 0,0 1 0,-5-3 0,4 7 0,-9-3 0,9 0 0,-9 3 0,9-3 0,-9 0 0,9 3 0,-4-3 0,5 0 0,1 2 0,-1-2 0,5-1 0,-3 3 0,9-8 0,-4 3 0,12 0 0,-4-3 0,4 3 0,-7-5 0,1 1 0,0-1 0,-6 2 0,4 3 0,-9-2 0,3 8 0,-4-8 0,-2 8 0,-3-7 0,2 6 0,-7-5 0,3 6 0,7-10 0,-9 9 0,15-6 0,-17 4 0,9 3 0,-4-7 0,5 7 0,-4-3 0,3-1 0,-4 4 0,5-8 0,0 8 0,0-8 0,-5 8 0,4-3 0,-4 0 0,5 2 0,0-6 0,-5 7 0,4-8 0,-4 8 0,1-7 0,-3 7 0,1-2 0,-3 3 0,3-4 0,-5 4 0,0-3 0,0 3 0,5 0 0,-4 0 0,4 1 0,-5-1 0,0 0 0,0 1 0,5-1 0,-3 0 0,3 0 0,-5 1 0,0-1 0,8-3 0,-7 6 0,7-5 0,-8 6 0,0-3 0,-4 3 0,3-3 0,-7 7 0,3-6 0,0 6 0,-4-5 0,4 5 0,-4-6 0,0 6 0,-1-6 0,1 6 0,0-6 0,-1 7 0,1-7 0,0 6 0,0-3 0,-1 1 0,1 2 0,0-6 0,-1 6 0,1-2 0,-4 0 0,3 2 0,-6-6 0,5 6 0,-2-6 0,4 7 0,-4-7 0,2 6 0,-1-2 0,-1 0 0,3 2 0,-3-6 0,3 6 0,1-5 0,-1 5 0,0-2 0,-3-1 0,3 3 0,-6-5 0,5 5 0,-2-5 0,4 5 0,-1-6 0,0 7 0,-3-7 0,2 6 0,-2-5 0,4 5 0,-1-2 0,-3-1 0,2 3 0,-2-2 0,0-1 0,3 4 0,-3-7 0,3 6 0,-3-5 0,3 5 0,-4-3 0,2 1 0,1 2 0,-2-2 0,0 0 0,2 2 0,-2-3 0,0 1 0,3 2 0,-3-2 0,3 0 0,0 2 0,0-2 0,1 3 0,-5-3 0,4 2 0,-3-2 0,3 3 0,0 0 0,-3-3 0,2 2 0,-2-3 0,0 1 0,3 3 0,-6-4 0,2 4 0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20.53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969 24575,'7'0'0,"5"0"0,1 0 0,4 0 0,0 0 0,5-8 0,1 6 0,5-15 0,6 11 0,-5-12 0,10 7 0,-2-13 0,5 1 0,1 0 0,5-7 0,1 7 0,6-10 0,0 0 0,0 0 0,0-1 0,0 6 0,-5-3 0,4 7 0,-9-8 0,-3 11 0,-1-5 0,-12 7 0,11-1 0,-11 1 0,0 0 0,3 0 0,-12 6 0,12-6 0,-14 10 0,9-9 0,-4 8 0,0-3 0,-1 0 0,0 4 0,-4-4 0,4 4 0,0 0 0,-3 1 0,2-1 0,-4 0 0,0 1 0,-4 3 0,3-2 0,-3 2 0,0-3 0,3 3 0,-7-2 0,3 6 0,0-6 0,-4 3 0,4-1 0,-4-2 0,4 6 0,-3-5 0,2 1 0,-3 1 0,0-3 0,0 6 0,3-6 0,-2 6 0,3-6 0,-4 6 0,-1-6 0,1 6 0,0-2 0,0 0 0,-1 2 0,1-6 0,0 6 0,-1-6 0,1 6 0,0-2 0,-1-1 0,1 4 0,0-4 0,-1 1 0,0 2 0,1-5 0,-1 5 0,0-2 0,-3-1 0,2 4 0,-2-7 0,4 6 0,-4-5 0,2 5 0,-2-3 0,0 1 0,3 2 0,-3-2 0,4 3 0,-4-4 0,2 3 0,-2-2 0,1 0 0,1 2 0,-2-5 0,4 5 0,-5-5 0,4 5 0,-3-2 0,0-1 0,-4 4 0,0-4 0,-3 4 0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25.52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984 24575,'7'0'0,"-3"-3"0,12-2 0,-10 0 0,11-6 0,0 5 0,-2-10 0,11 9 0,-2-8 0,-1 5 0,4-5 0,-4-2 0,5 7 0,6-8 0,-5 3 0,10-1 0,-4-2 0,0 3 0,5-6 0,-5 6 0,0-3 0,-1 3 0,-6-4 0,0 5 0,-1-4 0,2 8 0,-2-8 0,2 8 0,-6-3 0,3-1 0,-2 4 0,-1-3 0,-1 4 0,0 1 0,-4-1 0,4 0 0,0 0 0,-4-3 0,4 2 0,-5-2 0,0 3 0,5 0 0,-4 1 0,4-1 0,-5 0 0,0-3 0,5 2 0,-4-2 0,4 3 0,-5 0 0,0-3 0,0 3 0,0-4 0,0 5 0,-4 0 0,3-1 0,-3 1 0,0 0 0,3 0 0,-3-1 0,0 1 0,-1 0 0,-1 0 0,-2 0 0,3 0 0,3 0 0,-5 0 0,5 4 0,-7-3 0,0 3 0,-1-1 0,1-2 0,0 7 0,-1-7 0,1 6 0,0-6 0,0 3 0,-1-1 0,1-1 0,4 1 0,-3 1 0,2-4 0,1 4 0,-3-1 0,3-2 0,-5 3 0,5 0 0,-3-3 0,3 3 0,-4-1 0,-1-2 0,5 7 0,-3-7 0,3 6 0,-5-6 0,1 6 0,0-6 0,0 6 0,-1-5 0,1 5 0,0-6 0,-1 6 0,1-6 0,0 6 0,0-2 0,-1-1 0,1 0 0,0 0 0,-1-3 0,1 6 0,-1-2 0,1 0 0,-1 2 0,-3-5 0,3 5 0,-3-6 0,3 7 0,0-7 0,1 7 0,-1-7 0,0 6 0,0-2 0,0 3 0,-3-3 0,2 2 0,-5-5 0,5 5 0,-2-2 0,0 0 0,-1 2 0,-3-2 0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31.48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336 1 24575,'0'7'0,"-7"0"0,2 1 0,-6-1 0,3 1 0,0 4 0,0-7 0,-4 6 0,-1-6 0,-4 4 0,0-1 0,0 1 0,0 3 0,-5-2 0,4 6 0,-9-6 0,8 7 0,-7-7 0,7 6 0,-8-6 0,9 6 0,-9-5 0,9 5 0,-4-3 0,0 1 0,4 2 0,-4-6 0,9 6 0,-3-6 0,2 6 0,-3-7 0,4 3 0,-3-3 0,7 3 0,-3-3 0,4 3 0,1-5 0,-5 1 0,6 0 0,-9 1 0,10-2 0,-7 6 0,7-5 0,-2 4 0,3-4 0,-4 0 0,0-1 0,1 1 0,-1 4 0,0-3 0,0 2 0,-4-2 0,7 2 0,-6-1 0,2 2 0,0-5 0,-3 2 0,5-2 0,-1 5 0,-4-3 0,3 3 0,-4 0 0,6-3 0,-1 3 0,-4 0 0,3-3 0,-3 2 0,4-3 0,1 0 0,-1-1 0,0 1 0,1 0 0,-1 0 0,0-1 0,-4 1 0,4 0 0,-4 0 0,4 0 0,0 0 0,1-1 0,-1 1 0,0 0 0,4-1 0,-7 2 0,6-2 0,-7 1 0,7 0 0,-1 0 0,-3-4 0,0 3 0,-3-3 0,5 4 0,-1-4 0,0 3 0,1-3 0,-1 4 0,0-4 0,1 3 0,-1-3 0,0 4 0,0 0 0,1-4 0,-1 3 0,0-3 0,1 4 0,-1-4 0,4 3 0,-3-6 0,6 5 0,-6-5 0,3 6 0,-3-3 0,-1 4 0,1-4 0,3 2 0,-3-5 0,7 6 0,-7-6 0,3 5 0,-4-2 0,1 3 0,0 1 0,0-5 0,3 4 0,-3-6 0,6 6 0,-6-6 0,7 5 0,-7-5 0,3 6 0,-4-7 0,4 7 0,-2-6 0,5 5 0,-6-5 0,6 5 0,-5-5 0,2 5 0,-6-5 0,5 2 0,-1-3 0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36.71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2688 1 24575,'-11'0'0,"-3"0"0,1 0 0,-9 0 0,4 0 0,-9 0 0,4 0 0,-5 0 0,0 0 0,0 0 0,-6 0 0,-1 0 0,-6 0 0,6 0 0,-4 0 0,10 0 0,-11 0 0,5 0 0,0 0 0,-4 0 0,9 4 0,-3-3 0,-1 7 0,4-6 0,-3 2 0,-1 1 0,4-4 0,-9 8 0,10-8 0,-10 3 0,4 1 0,0-4 0,1 3 0,0 1 0,5-4 0,-5 8 0,6-8 0,-6 3 0,5 0 0,-5-3 0,6 8 0,0-8 0,0 7 0,-6-3 0,10 1 0,-9 2 0,10-7 0,-5 8 0,5-8 0,-4 7 0,4-7 0,-5 7 0,5-7 0,-4 3 0,4 1 0,-5-4 0,4 3 0,-2 0 0,2-3 0,-4 3 0,5-4 0,-4 0 0,9 0 0,-9 0 0,9 0 0,-4 0 0,5 4 0,0-3 0,0 3 0,-5-4 0,4 0 0,-4 0 0,4 0 0,6 3 0,-5-2 0,5 2 0,-6-3 0,1 0 0,0 0 0,4 4 0,-3-3 0,8 2 0,-8-3 0,7 0 0,-7 4 0,7-3 0,-3 3 0,5-4 0,-1 0 0,0 0 0,0 0 0,1 0 0,-1 0 0,0 0 0,-4 0 0,4 0 0,-4 0 0,4 0 0,0 0 0,1 0 0,-1 0 0,0 0 0,1 0 0,-1 0 0,0 0 0,-7 0 0,5 0 0,-5 0 0,7 0 0,1 0 0,-1 0 0,-4 0 0,3 0 0,-3 0 0,5 0 0,-1 0 0,0 0 0,0 0 0,1 0 0,-1 0 0,1 0 0,-1 0 0,0 0 0,1 0 0,-1 0 0,0 0 0,1 0 0,-1 0 0,1 0 0,-1 0 0,1 0 0,-1 0 0,1 0 0,-1 0 0,1 0 0,-1 0 0,1 0 0,0 0 0,-1 0 0,1 0 0,0 0 0,0 0 0,0 0 0,3 0 0,1 0 0</inkml:trace>
</inkml:ink>
</file>

<file path=ppt/ink/ink1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6:45.680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632 534 24575,'-11'0'0,"-4"0"0,7 0 0,-13 0 0,11 0 0,-16 0 0,12 0 0,-13-4 0,4-5 0,0-1 0,-4-8 0,4 8 0,-11-4 0,-1 0 0,0-1 0,-4-1 0,4-2 0,0 3 0,-5-6 0,5 2 0,0 3 0,-4-3 0,4 4 0,0-1 0,1-2 0,6 7 0,0-2 0,4 4 0,2 0 0,5 0 0,0 1 0,0 3 0,0-3 0,4 8 0,1-8 0,1 7 0,2-2 0,-3 0 0,4 2 0,1-3 0,-1 4 0,0-3 0,1 2 0,-1-2 0,0 3 0,1 0 0,-1 0 0,0 0 0,1-3 0,-1 2 0,0-3 0,0 4 0,1-3 0,-5 2 0,3-2 0,-3-1 0,4 3 0,-3-2 0,2-1 0,-3 4 0,4-7 0,-4 6 0,4-3 0,-4 1 0,4 2 0,-4-6 0,3 6 0,-2-3 0,3 4 0,0-3 0,1 2 0,-1-3 0,0 4 0,1 0 0,-1 0 0,0-3 0,1 2 0,-1-2 0,1 3 0,-1 0 0,0 0 0,0-3 0,1 2 0,-1-6 0,0 6 0,1-2 0,-1-1 0,0 3 0,1-2 0,-1 0 0,-4 2 0,3-3 0,-3 1 0,5 2 0,-1-6 0,0 6 0,1-2 0,-1-1 0,0 4 0,1-4 0,-1 4 0,0 0 0,1 0 0,-1 0 0,1 0 0,-1-3 0,1 2 0,0-2 0,-1 3 0,1 0 0,0 0 0,0 0 0,0 0 0,0 0 0,0 0 0,3-4 0,-3 4 0,4-4 0,-4 4 0,3-3 0,-3 2 0,3-2 0,0 0 0,-2 2 0,2-3 0,-3 4 0,0-3 0,0 2 0,3-5 0,1 5 0,3-2 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4:51.82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410 24575,'7'0'0,"0"0"0,0 0 0,5-8 0,-3 6 0,3-5 0,-4-1 0,4 6 0,-3-5 0,7 3 0,-7-1 0,7-3 0,-7 0 0,7 3 0,-4-2 0,1 3 0,3-1 0,-7-2 0,7 3 0,-7-4 0,7 3 0,-7-2 0,2 7 0,1-8 0,-3 4 0,3-1 0,-4-1 0,-1 5 0,1-6 0,0 3 0,0-1 0,-1-2 0,1 7 0,0-7 0,-1 6 0,1-6 0,0 3 0,0-1 0,-1-1 0,1 5 0,0-6 0,-1 6 0,1-6 0,0 3 0,-1 0 0,1-3 0,0 6 0,0-6 0,-1 6 0,1-6 0,0 3 0,-1 0 0,1-3 0,0 6 0,0-2 0,-1-1 0,1 3 0,4-6 0,-3 6 0,3-3 0,-1 1 0,-2 2 0,3-7 0,-4 7 0,-1-5 0,5 5 0,-3-3 0,3 1 0,-4 2 0,-1-2 0,1-1 0,4 3 0,-3-2 0,2 0 0,-3 2 0,0-6 0,0 6 0,-1-2 0,1 3 0,0-4 0,-1 3 0,1-2 0,0-1 0,0 4 0,-1-7 0,1 6 0,0-3 0,-1 1 0,1 2 0,-1-2 0,1 3 0,0-3 0,-1 2 0,1-3 0,-4 1 0,3 2 0,-3-2 0,4-1 0,-1 4 0,-3-7 0,3 6 0,-3-2 0,4 3 0,-4-4 0,2 3 0,-2-2 0,1-1 0,1 4 0,-2-4 0,3 4 0,0 0 0,-3-3 0,3 2 0,-6-2 0,2 3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4:55.595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1 24575,'7'0'0,"0"0"0,1 0 0,-1 0 0,1 0 0,0 0 0,-1 0 0,1 0 0,0 0 0,-1 0 0,1 0 0,0 0 0,-1 0 0,1 3 0,0-2 0,-1 6 0,1-6 0,0 2 0,-1-3 0,1 0 0,0 3 0,-1-2 0,1 3 0,0-4 0,-1 0 0,1 3 0,-1-2 0,1 2 0,0-3 0,-1 0 0,1 3 0,0-2 0,0 3 0,-1-1 0,1-2 0,-1 2 0,1-3 0,-4 3 0,2-2 0,-2 2 0,4-3 0,-4 4 0,2-4 0,-1 4 0,2-4 0,-3 3 0,2-2 0,-2 2 0,4-3 0,-1 3 0,0-2 0,0 2 0,-3-3 0,-1 0 0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02.929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122 24575,'11'0'0,"9"0"0,-10 0 0,16 0 0,-12 0 0,13 0 0,-4 0 0,5 0 0,0 0 0,6 0 0,-5 0 0,11 0 0,-5 0 0,6 0 0,0 0 0,-1 0 0,1 0 0,-1-9 0,8 7 0,-6-7 0,5 9 0,-6 0 0,0 0 0,0 0 0,-1 0 0,1 0 0,0 0 0,0 0 0,-1 0 0,1-5 0,0 4 0,-6-3 0,4 4 0,-4-5 0,1 4 0,3-3 0,-4-1 0,6 4 0,0-4 0,-6 1 0,11 3 0,-15-3 0,15 4 0,-12-5 0,7 4 0,0-3 0,0 4 0,-1 0 0,1-5 0,0 4 0,0-3 0,6-1 0,2 4 0,-1-9 0,0 9 0,-1-4 0,-5 1 0,5 3 0,-6-8 0,0 8 0,0-4 0,-6 5 0,-1 0 0,-6 0 0,0 0 0,0 0 0,-5 0 0,4 0 0,-9 0 0,4 0 0,-9 0 0,3 0 0,-3 0 0,4 0 0,-4 0 0,3 0 0,-3 0 0,0 0 0,3 0 0,-3 0 0,9 4 0,-4-3 0,4 3 0,-5 0 0,5-3 0,-4 3 0,9-4 0,-4 4 0,0-3 0,4 3 0,-8-4 0,8 0 0,-4 0 0,0 0 0,4 0 0,-9 0 0,9 0 0,-9 0 0,9 0 0,-9 0 0,4 4 0,-5-3 0,1 3 0,-1-4 0,-5 0 0,5 0 0,-9 3 0,4-2 0,0 3 0,-3-4 0,3 0 0,-5 0 0,1 0 0,0 0 0,-1 0 0,1 0 0,0 0 0,0 0 0,-1 0 0,1 0 0,0 0 0,-1 0 0,1 0 0,0 0 0,-1 0 0,1 0 0,-1 0 0,1 0 0,-4 3 0,3-2 0,-3 2 0,3-3 0,1 0 0,-1 0 0,0 0 0,1 0 0,-1 0 0,1 0 0,-1 0 0,0 0 0,1 0 0,-1 0 0,0 0 0,0 0 0,1 0 0,-1 0 0,0 0 0,0 0 0,1 0 0,-1 0 0,0 0 0,0 0 0,0 0 0,0 0 0,0 0 0,0 0 0,0 0 0,0 0 0,0 0 0,0 0 0,0 0 0,0 0 0,0 0 0,-3 0 0,-1 0 0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16.614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1 24575,'16'4'0,"-2"3"0,13 2 0,1-3 0,14 17 0,0-15 0,19 23 0,-17-22 0,17 21 0,-6-15 0,-3 17 0,16-8 0,-16 8 0,17-13 0,-12 12 0,5-7 0,-13 3 0,5 5 0,-12-10 0,1 8 0,-4-8 0,-8 2 0,3-5 0,-11-1 0,5 6 0,-10-5 0,10 5 0,-5-7 0,5 2 0,0 0 0,2 5 0,-2-4 0,1 4 0,0 0 0,0-4 0,0 4 0,0 0 0,-1-4 0,7 5 0,-4-1 0,-2-4 0,-1 4 0,-5-6 0,6 6 0,-5-5 0,3 5 0,-8-7 0,3 1 0,-5-1 0,0 0 0,0 0 0,0 0 0,0 0 0,-4 0 0,3-4 0,-6 3 0,2-2 0,0-1 0,-2 3 0,6-3 0,-7 0 0,7 3 0,-7-7 0,7 7 0,-7-3 0,7 0 0,-6 3 0,2-7 0,-4 7 0,0-7 0,0 7 0,4-7 0,-2 7 0,2-7 0,-4 3 0,-1-4 0,1 4 0,0-3 0,0 2 0,0-3 0,0 0 0,0 4 0,0-4 0,0 4 0,-1-4 0,1 0 0,0-1 0,-1 1 0,1 0 0,0 0 0,0-1 0,-4 1 0,3 0 0,-3-1 0,4 1 0,-4 0 0,3-1 0,-3 1 0,0 0 0,3 0 0,-3-1 0,4 1 0,0 0 0,0-1 0,-4 1 0,3 0 0,-3-1 0,4 1 0,-4 0 0,3 0 0,-3-1 0,4 1 0,-1 0 0,1-1 0,0 1 0,-1 0 0,1-1 0,-1 1 0,1-1 0,-1-3 0,-3 3 0,3-6 0,-6 6 0,6-7 0,-3 7 0,1-3 0,1 1 0,-1 1 0,2-2 0,1 4 0,-4-1 0,2-3 0,-5 3 0,6-3 0,-3 4 0,3-1 0,1 0 0,-1 1 0,0-1 0,-3 1 0,3-1 0,-3-3 0,0 3 0,2-3 0,-5 3 0,6-3 0,-3 3 0,3-3 0,1 3 0,-1-3 0,-3 2 0,2-5 0,-5 6 0,2-3 0,0 0 0,-2 2 0,6-5 0,-6 5 0,2-2 0,0 0 0,-2 3 0,3-3 0,-1 0 0,-2 2 0,5-5 0,-5 5 0,2-2 0,0 0 0,-2 2 0,6-5 0,-7 5 0,4-5 0,-4 2 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19.991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594 0 24575,'0'3'0,"0"-1"0,0 9 0,0 1 0,0-3 0,0 3 0,0-5 0,0 1 0,0 0 0,0-1 0,0 10 0,0-7 0,0 11 0,0-3 0,0 0 0,-9 14 0,6-12 0,-16 24 0,12-12 0,-8 15 0,0-6 0,-1 6 0,-1 2 0,2 6 0,-1-7 0,4 6 0,-2-12 0,-1 0 0,4-3 0,-3-4 0,4 0 0,1-1 0,0-11 0,-1 4 0,2-9 0,3 4 0,-3-5 0,3 0 0,-3 0 0,3 0 0,-3 0 0,4 0 0,-1 0 0,-3 5 0,3-4 0,-4 9 0,0-9 0,0 9 0,0-4 0,0 0 0,0 4 0,0-4 0,0 1 0,0 2 0,0-2 0,-1 4 0,1-1 0,0 1 0,-1 0 0,1-4 0,0 2 0,1-7 0,-2 7 0,2-7 0,3 3 0,-3-5 0,3 0 0,1-4 0,-4-1 0,7-1 0,-2-2 0,0 3 0,2-4 0,-6-1 0,6 1 0,-2 0 0,-1-1 0,3 1 0,-2 0 0,3 0 0,0-1 0,-4 1 0,4-1 0,-7 1 0,6-1 0,-2 0 0,0 1 0,2-1 0,-2 0 0,3 1 0,-4-4 0,3 2 0,-2-2 0,3 4 0,0-1 0,-4-3 0,4 2 0,-4-2 0,1 3 0,2 0 0,-5 0 0,5 1 0,-6-1 0,7 0 0,-4 0 0,4 0 0,0-3 0,0-1 0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25.02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1 24575,'7'7'0,"1"5"0,4-3 0,-2 7 0,6-7 0,-3 7 0,0-2 0,3 3 0,-2 0 0,8 6 0,-7-5 0,13 11 0,-8-10 0,4 5 0,4-1 0,-4 2 0,1-1 0,4 5 0,-5-4 0,6 0 0,-5 3 0,2-8 0,-7 7 0,7-7 0,-8 7 0,3-8 0,2 9 0,-5-10 0,5 10 0,-7-9 0,1 8 0,0-9 0,0 9 0,0-4 0,-4 0 0,4 4 0,-5-9 0,5 4 0,0 0 0,0 1 0,-4 0 0,3 4 0,-3-9 0,0 8 0,2-7 0,-6 2 0,7 1 0,-8-3 0,8 3 0,-7 0 0,3-4 0,-4 9 0,3-9 0,-2 4 0,2-5 0,-3 5 0,0-4 0,0 4 0,3-5 0,-2 0 0,2 5 0,-3-3 0,0 2 0,3-7 0,-2 2 0,2-3 0,-4 4 0,1 0 0,3 0 0,-3-4 0,4 3 0,-6-7 0,6 7 0,-4-3 0,3 0 0,-4 3 0,0-3 0,5 0 0,-4 3 0,3-3 0,-3 4 0,-1-4 0,1 3 0,3-3 0,-3 4 0,3-4 0,-4 3 0,1-3 0,-1 4 0,1 0 0,-1-4 0,0 3 0,0-3 0,1 4 0,-1-4 0,0 3 0,0-8 0,1 8 0,-2-7 0,2 7 0,-1-7 0,-4 3 0,3-1 0,-6-2 0,7 3 0,-4 0 0,4-3 0,-3 3 0,2-5 0,-3 5 0,1-3 0,2 3 0,-3-5 0,0 1 0,3 0 0,-6 0 0,6-1 0,-3 1 0,1 0 0,1-1 0,-5 1 0,6-4 0,-3 3 0,1-2 0,2 2 0,-3 1 0,3-1 0,-3 1 0,3-4 0,-6 3 0,5-3 0,-2 3 0,0 1 0,3-4 0,-6 2 0,5-2 0,-5 4 0,6-4 0,-7 2 0,7-5 0,-6 5 0,2-1 0,1-1 0,-4 2 0,7-5 0,-6 6 0,6-6 0,-6 5 0,6-5 0,-6 6 0,5-3 0,-2 4 0,0-1 0,3-3 0,-6 2 0,5-5 0,-5 6 0,6-6 0,-7 6 0,4-3 0,-1 0 0,-2 2 0,6-5 0,-6 5 0,5-5 0,-5 5 0,2-2 0,0 0 0,-2-1 0,2-3 0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31.162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1 3621 24575,'0'-8'0,"0"-3"0,0-1 0,0-5 0,0 5 0,0-4 0,0 3 0,4-4 0,-3 4 0,6-3 0,-2 3 0,3-4 0,-3 0 0,2 4 0,-2-3 0,3 3 0,0 0 0,1-3 0,-1 3 0,-3 0 0,2-3 0,-2 7 0,3-3 0,0 0 0,0 4 0,0-8 0,0 7 0,0-3 0,0 4 0,-4-4 0,3 4 0,-3-4 0,4 4 0,-4 0 0,3-3 0,-2 2 0,3-3 0,-1 4 0,1 1 0,-4-5 0,3 3 0,-2-7 0,3 7 0,0-7 0,0 8 0,0-9 0,0 5 0,1-10 0,4 3 0,1-8 0,0 9 0,3-9 0,-7 4 0,7 0 0,-3-4 0,0 9 0,3-9 0,-3 9 0,0-9 0,3 4 0,-3 0 0,4-4 0,-4 9 0,3-9 0,-3 9 0,4-9 0,0 4 0,1-5 0,0 0 0,-1 0 0,1 0 0,-1 0 0,1 0 0,0 0 0,0-6 0,0 5 0,0-4 0,1-1 0,-5 4 0,4-9 0,2 2 0,1-4 0,4-1 0,-6 1 0,0 0 0,6-1 0,2-5 0,5 1 0,0-2 0,0 3 0,0 2 0,5-1 0,-4 0 0,10-7 0,-9 5 0,4-4 0,-1 6 0,-5 6 0,4-4 0,-11 11 0,4-5 0,-9 2 0,7 7 0,-8-5 0,3 8 0,-4-4 0,7-8 0,-10 11 0,9-5 0,-16 13 0,4 0 0,-1 4 0,-3-3 0,3 7 0,-3-7 0,-2 7 0,2-3 0,-2 4 0,1-3 0,-3 2 0,2 0 0,-3 2 0,1 3 0,1-4 0,-5 1 0,6-1 0,-3 0 0,4 1 0,-4-1 0,3-4 0,-2 4 0,-1-4 0,3 4 0,-2-4 0,2 4 0,2-9 0,-1 9 0,0-8 0,0 7 0,0-7 0,1 3 0,-1-4 0,1 0 0,-1 4 0,0-3 0,0 3 0,0 0 0,1-3 0,-1 7 0,0-7 0,0 8 0,0-4 0,0 0 0,0 3 0,0-3 0,0 5 0,-1-1 0,1 0 0,0 1 0,0-1 0,-1 0 0,1-4 0,-3 3 0,2 1 0,-2-3 0,2 6 0,-2-7 0,2 4 0,-3 0 0,4 4 0,-4-7 0,3 9 0,-3-9 0,1 7 0,1-4 0,-1 0 0,2 1 0,-3-1 0,3 1 0,-3-1 0,4 1 0,-4-1 0,2 4 0,-5-2 0,3 1 0,-1 1 0,-2-3 0,6 3 0,-3-3 0,3-1 0,-3 1 0,3 3 0,-6-3 0,5 6 0,-5-5 0,6 2 0,-6-4 0,5 4 0,-5-3 0,6 3 0,-6-3 0,6 3 0,-7-3 0,7 3 0,-3-4 0,0 1 0,3 3 0,-6-3 0,2 3 0,1 0 0,0-2 0,0 1 0,2-2 0,-5 0 0,6 3 0,-6-3 0,5 7 0,-5-7 0,2 3 0,1-4 0,-3 1 0,5 3 0,-5-3 0,2 3 0,1 0 0,-4-3 0,7 3 0,-6-3 0,5 3 0,-5-2 0,6 5 0,-6-5 0,5 2 0,-5-3 0,2 0 0,0 3 0,1 1 0,0-1 0,3 3 0,-6-5 0,5 5 0,-5-5 0,-1 5 0,0-2 0,-4 3 0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5-21T21:15:38.745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0 24575,'0'8'0,"0"-1"0,0 1 0,0-1 0,0 1 0,0 0 0,0 4 0,0 0 0,0 10 0,0 1 0,0 1 0,0 2 0,0 3 0,0 1 0,0 9 0,0-4 0,0 0 0,0 5 0,0-5 0,0 5 0,0-4 0,5 3 0,-4-4 0,8 0 0,-8 4 0,3-9 0,0 9 0,-3-10 0,4 11 0,-1-11 0,-3 5 0,3-1 0,-4-3 0,4 3 0,-3-5 0,4 6 0,-5-5 0,0 5 0,4-6 0,-3 5 0,3-3 0,-4 4 0,0-1 0,0-3 0,4 9 0,-2-9 0,2 3 0,-4 1 0,0-5 0,4 5 0,-3-6 0,3 6 0,-4-5 0,5 5 0,-4-11 0,3 4 0,-4-4 0,0 1 0,4-2 0,-3-1 0,2-2 0,-3 3 0,0-5 0,4 0 0,-3 0 0,3 0 0,-4-4 0,0 3 0,0-3 0,0 0 0,4 3 0,-3-3 0,2-1 0,-3 4 0,4-3 0,-3 0 0,3 3 0,-1-7 0,-2 3 0,3 0 0,-4-4 0,3 8 0,-2-7 0,3 3 0,-4 0 0,0-3 0,0 7 0,4-8 0,-4 4 0,4 0 0,-4-3 0,0 7 0,0-7 0,0 2 0,0 1 0,0-3 0,0 7 0,0-7 0,0 3 0,0-5 0,0 1 0,0 4 0,0-3 0,0 3 0,0-5 0,0 1 0,0 0 0,0-1 0,0 1 0,0 0 0,0-1 0,0 1 0,0-1 0,3 1 0,-2-1 0,3 1 0,-4-1 0,0 1 0,0-1 0,0 1 0,0-1 0,0 1 0,0-1 0,0 1 0,0-1 0,0 1 0,0-1 0,0 1 0,0-1 0,0 1 0,0-1 0,0 1 0,0 0 0,0-1 0,0 1 0,0-1 0,0 1 0,0 0 0,0-1 0,0 1 0,0 0 0,0-1 0,0 1 0,0 0 0,0-1 0,0 1 0,0-1 0,0 1 0,0 0 0,0-1 0,0 1 0,0-1 0,0 1 0,0-1 0,0 1 0,0-1 0,0 0 0,0 1 0,0-1 0,0 1 0,0-1 0,0 0 0,0 0 0,0 0 0,3-3 0,-3-1 0,3-3 0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5156D-C095-2149-991D-E4DC358E7D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AF8459-8E31-9A69-1109-BAD68B88D5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46AA17-2380-F861-B140-776022F78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B9C57E-D080-FA51-69F9-F00C36AF0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4E8BD3-7637-0B37-3293-E6DECFDAD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475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8BA583-BEAB-01A6-1EE4-EAC6F98AA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3464212-E39E-6A69-C98F-4C3337D06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9C0040-C0BD-6E1B-3AC9-E00397D82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24DFCA-65CE-40E9-221F-A7C6A16FC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697C40-21C8-CCBB-C0A4-21C81DEAA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305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443E8E-F769-A93F-037A-B6DEA4368D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39A2FB-99C1-166C-CA99-F13AFC0BAA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4AA534-B846-0A1C-4606-8735E0B694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9F5A3-C6F1-482A-B9AC-9FC43917F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9DFC26-D7F7-F14D-50B5-963E5AAD7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02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7D2EE6-1737-CE63-52FB-C41125087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C5AC7-2F1E-308E-1A6B-BB94926E2B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87D24-3E2C-2617-F988-07BAA22384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20842-14BB-30BC-9CEF-891013CB3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09CC7C-5FC2-B103-644B-D6C4F76E9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9105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D2277-26F2-4D17-AE68-BD64D6BE94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F363B8-90A0-5BE6-8C1F-75937B5637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0D5B38-3781-9D1B-CC8B-4FB39646E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97F7B1-5497-EC5C-1CCE-38FC132F74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93DB38-08B5-EEC1-FC62-3F91E73F3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46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15D543-5EB3-4258-1FDC-F9E3DFCCA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A5297F-AFEE-1116-C71E-713F0D1FE1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36CC91-1806-4229-A30F-34D2E565D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1F9E40-F6C1-F4EC-84DE-92CEF37F3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C84C35-2DA9-690B-E66A-48D83AEF17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E23134-9966-07FA-B8C8-221B658C23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27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91586-360C-F81F-FF82-CAEBB15DC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73420F-50D6-E7C2-6AB6-ACAF9B3101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9932C80-25C2-B9BD-604D-470743A46B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64443E-FBE1-D596-DDA9-0B5E21A306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9A3D08-B79C-0683-C9FB-4A2306C12A8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45F97B-62B0-E401-2BB5-BB6226B4C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88CD1E-0076-E15F-0786-B121EA8DD1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48D4D0-A852-8253-77AE-D9333180A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635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8B2A0F-19F6-DF6A-71C6-BFC9DE361D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0DFDDB-C4BA-A2E8-5343-9BE63EC0D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2A7F21D-BC92-1EDB-7A93-F24446181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DCDA7E2-E71D-7D5D-08BE-D99742B3B5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209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F251CDA-2E28-A43C-0F6C-5EADDDE2C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2D2C1E-F44E-047B-1E96-61FAFDCC9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92DF1A4-5BAC-7F5C-6609-BB9CF04BE3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614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9664F-7E2D-2F99-67A6-FB2FDB0A8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AC5FDB-B1DE-DC3E-5968-EC122E5E51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E04C7F-6832-ECA6-10ED-DBCC82BFC7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3BF602-EB4E-4792-932B-DB344B0E98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993F87-DF74-36CF-BF5E-8E169C210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6FDC20-9D2A-AEB9-430A-C4DE5242B1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68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FDFF6-AF55-54CD-BC27-E3814D7146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71CB05-9C09-9316-F9F8-260A45F04F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1FA8D1F-423A-8874-628A-758963A64A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CFF396-625B-A186-2B3B-6FF498453B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12DCBC-D4DC-7A31-8B24-38626634E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387703-063C-598B-1D5D-936D048922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482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72C3EB-0BA5-C069-5F93-093228C8F5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0B9D95-2133-4067-5241-89CC2D70C1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4BF20-D7C0-0A77-583B-6A95CBC268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6234D-A716-704F-AA3B-9A118E51B73F}" type="datetimeFigureOut">
              <a:rPr lang="en-US" smtClean="0"/>
              <a:t>5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B69977-A861-741D-C9DF-F6731B91CD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9E6C13-46FC-7A27-F427-FC19A2E6C6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6EA351-E6CA-1644-BC6C-F793800A27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763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png"/><Relationship Id="rId18" Type="http://schemas.openxmlformats.org/officeDocument/2006/relationships/customXml" Target="../ink/ink9.xml"/><Relationship Id="rId26" Type="http://schemas.openxmlformats.org/officeDocument/2006/relationships/customXml" Target="../ink/ink13.xml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7" Type="http://schemas.openxmlformats.org/officeDocument/2006/relationships/image" Target="../media/image3.png"/><Relationship Id="rId12" Type="http://schemas.openxmlformats.org/officeDocument/2006/relationships/customXml" Target="../ink/ink6.xml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2" Type="http://schemas.openxmlformats.org/officeDocument/2006/relationships/customXml" Target="../ink/ink1.xml"/><Relationship Id="rId16" Type="http://schemas.openxmlformats.org/officeDocument/2006/relationships/customXml" Target="../ink/ink8.xml"/><Relationship Id="rId20" Type="http://schemas.openxmlformats.org/officeDocument/2006/relationships/customXml" Target="../ink/ink10.xml"/><Relationship Id="rId29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customXml" Target="../ink/ink3.xml"/><Relationship Id="rId11" Type="http://schemas.openxmlformats.org/officeDocument/2006/relationships/image" Target="../media/image5.png"/><Relationship Id="rId24" Type="http://schemas.openxmlformats.org/officeDocument/2006/relationships/customXml" Target="../ink/ink12.xml"/><Relationship Id="rId32" Type="http://schemas.openxmlformats.org/officeDocument/2006/relationships/customXml" Target="../ink/ink16.xml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openxmlformats.org/officeDocument/2006/relationships/customXml" Target="../ink/ink14.xml"/><Relationship Id="rId10" Type="http://schemas.openxmlformats.org/officeDocument/2006/relationships/customXml" Target="../ink/ink5.xml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" Type="http://schemas.openxmlformats.org/officeDocument/2006/relationships/customXml" Target="../ink/ink2.xml"/><Relationship Id="rId9" Type="http://schemas.openxmlformats.org/officeDocument/2006/relationships/image" Target="../media/image4.png"/><Relationship Id="rId14" Type="http://schemas.openxmlformats.org/officeDocument/2006/relationships/customXml" Target="../ink/ink7.xml"/><Relationship Id="rId22" Type="http://schemas.openxmlformats.org/officeDocument/2006/relationships/customXml" Target="../ink/ink11.xml"/><Relationship Id="rId27" Type="http://schemas.openxmlformats.org/officeDocument/2006/relationships/image" Target="../media/image13.png"/><Relationship Id="rId30" Type="http://schemas.openxmlformats.org/officeDocument/2006/relationships/customXml" Target="../ink/ink15.xml"/><Relationship Id="rId8" Type="http://schemas.openxmlformats.org/officeDocument/2006/relationships/customXml" Target="../ink/ink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3A43DF-8496-A1C9-02B2-1A5EBF24CCDC}"/>
              </a:ext>
            </a:extLst>
          </p:cNvPr>
          <p:cNvSpPr>
            <a:spLocks noGrp="1"/>
          </p:cNvSpPr>
          <p:nvPr>
            <p:ph type="title"/>
          </p:nvPr>
        </p:nvSpPr>
        <p:spPr>
          <a:solidFill>
            <a:schemeClr val="bg1"/>
          </a:solidFill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1.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pping Social Relations and Institutional Texts (Turner, 2006)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442712E4-2090-F891-18A9-31F75879C323}"/>
              </a:ext>
            </a:extLst>
          </p:cNvPr>
          <p:cNvSpPr/>
          <p:nvPr/>
        </p:nvSpPr>
        <p:spPr>
          <a:xfrm>
            <a:off x="5720862" y="3024554"/>
            <a:ext cx="621323" cy="597877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0F1B7E75-E274-AA18-61D0-FCEF71A11D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1" y="1690688"/>
            <a:ext cx="10977562" cy="4376669"/>
          </a:xfrm>
          <a:prstGeom prst="ellipse">
            <a:avLst/>
          </a:prstGeom>
          <a:solidFill>
            <a:schemeClr val="bg1"/>
          </a:solidFill>
          <a:ln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indent="0">
              <a:buNone/>
            </a:pPr>
            <a:endParaRPr lang="en-US" b="1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63FCEA3A-D3E5-F2BC-E67B-572DD4F44705}"/>
              </a:ext>
            </a:extLst>
          </p:cNvPr>
          <p:cNvSpPr/>
          <p:nvPr/>
        </p:nvSpPr>
        <p:spPr>
          <a:xfrm>
            <a:off x="265814" y="2515298"/>
            <a:ext cx="11926186" cy="2539687"/>
          </a:xfrm>
          <a:prstGeom prst="ellipse">
            <a:avLst/>
          </a:prstGeom>
          <a:solidFill>
            <a:schemeClr val="bg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D6AE6AB-C9E1-4E3B-ABC1-CCF81BE65855}"/>
              </a:ext>
            </a:extLst>
          </p:cNvPr>
          <p:cNvSpPr/>
          <p:nvPr/>
        </p:nvSpPr>
        <p:spPr>
          <a:xfrm>
            <a:off x="1215688" y="3940170"/>
            <a:ext cx="1637415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Sexual Harassment Policy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E21AC52-FBB8-A0DA-6286-C88DC961F2B0}"/>
              </a:ext>
            </a:extLst>
          </p:cNvPr>
          <p:cNvSpPr/>
          <p:nvPr/>
        </p:nvSpPr>
        <p:spPr>
          <a:xfrm>
            <a:off x="3515595" y="3915473"/>
            <a:ext cx="1637415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Recommendations to the university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BE5C5D2-2457-10BD-408A-EF67C3042DBF}"/>
              </a:ext>
            </a:extLst>
          </p:cNvPr>
          <p:cNvSpPr/>
          <p:nvPr/>
        </p:nvSpPr>
        <p:spPr>
          <a:xfrm>
            <a:off x="5509372" y="3940170"/>
            <a:ext cx="1637415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Standalone sexual violence policy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FC27534-5370-B50C-DF85-649EDCC80025}"/>
              </a:ext>
            </a:extLst>
          </p:cNvPr>
          <p:cNvSpPr/>
          <p:nvPr/>
        </p:nvSpPr>
        <p:spPr>
          <a:xfrm>
            <a:off x="5410199" y="5606825"/>
            <a:ext cx="1637415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Ontario Human Rights Code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83EB555B-B396-C2B7-0242-D97D909F259C}"/>
              </a:ext>
            </a:extLst>
          </p:cNvPr>
          <p:cNvSpPr/>
          <p:nvPr/>
        </p:nvSpPr>
        <p:spPr>
          <a:xfrm>
            <a:off x="4320362" y="1906954"/>
            <a:ext cx="1637415" cy="4572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It’s Never Okay Action Pla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6BDA0CF-20B3-A5E3-CA93-E6ABE071426D}"/>
              </a:ext>
            </a:extLst>
          </p:cNvPr>
          <p:cNvSpPr/>
          <p:nvPr/>
        </p:nvSpPr>
        <p:spPr>
          <a:xfrm>
            <a:off x="6470192" y="1909320"/>
            <a:ext cx="1459371" cy="45483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  <a:cs typeface="Times New Roman" panose="02020603050405020304" pitchFamily="18" charset="0"/>
              </a:rPr>
              <a:t>Bill 132</a:t>
            </a:r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14545394-CF4A-CF18-D847-7AF8607B9485}"/>
              </a:ext>
            </a:extLst>
          </p:cNvPr>
          <p:cNvSpPr/>
          <p:nvPr/>
        </p:nvSpPr>
        <p:spPr>
          <a:xfrm>
            <a:off x="2318881" y="1774658"/>
            <a:ext cx="925033" cy="919205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Media </a:t>
            </a:r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E1B70FF3-7689-1946-4D61-56FF56DABE66}"/>
              </a:ext>
            </a:extLst>
          </p:cNvPr>
          <p:cNvSpPr/>
          <p:nvPr/>
        </p:nvSpPr>
        <p:spPr>
          <a:xfrm>
            <a:off x="1103314" y="2013077"/>
            <a:ext cx="925034" cy="925223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Students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46100382-84A9-4A0E-3104-2339747C17FA}"/>
              </a:ext>
            </a:extLst>
          </p:cNvPr>
          <p:cNvSpPr/>
          <p:nvPr/>
        </p:nvSpPr>
        <p:spPr>
          <a:xfrm>
            <a:off x="3968722" y="3090863"/>
            <a:ext cx="877920" cy="843099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Task Force</a:t>
            </a:r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D7149ABA-38A9-ADA6-0205-C6D4C062B289}"/>
              </a:ext>
            </a:extLst>
          </p:cNvPr>
          <p:cNvSpPr/>
          <p:nvPr/>
        </p:nvSpPr>
        <p:spPr>
          <a:xfrm>
            <a:off x="7836467" y="3118044"/>
            <a:ext cx="793357" cy="835772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ERC</a:t>
            </a:r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8DD6ABD6-0630-45A5-BAF6-5BC9DCDBB646}"/>
              </a:ext>
            </a:extLst>
          </p:cNvPr>
          <p:cNvSpPr/>
          <p:nvPr/>
        </p:nvSpPr>
        <p:spPr>
          <a:xfrm>
            <a:off x="5865564" y="3067138"/>
            <a:ext cx="881411" cy="873091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solidFill>
                  <a:schemeClr val="tx1"/>
                </a:solidFill>
              </a:rPr>
              <a:t>Action Team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76E2DDCF-2B3F-4162-9B32-3F231687DE74}"/>
              </a:ext>
            </a:extLst>
          </p:cNvPr>
          <p:cNvSpPr/>
          <p:nvPr/>
        </p:nvSpPr>
        <p:spPr>
          <a:xfrm>
            <a:off x="9617445" y="3016251"/>
            <a:ext cx="1023946" cy="1001575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>
                <a:solidFill>
                  <a:schemeClr val="tx1"/>
                </a:solidFill>
              </a:rPr>
              <a:t>Review Committee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BD0FF9B-321E-AFB5-33ED-55F86806D930}"/>
              </a:ext>
            </a:extLst>
          </p:cNvPr>
          <p:cNvSpPr/>
          <p:nvPr/>
        </p:nvSpPr>
        <p:spPr>
          <a:xfrm>
            <a:off x="7407755" y="5280058"/>
            <a:ext cx="1900368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chemeClr val="tx1"/>
                </a:solidFill>
              </a:rPr>
              <a:t>Sexual Violence Metrics/Reports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A1F68203-DAB5-2BD2-0576-203671714A03}"/>
              </a:ext>
            </a:extLst>
          </p:cNvPr>
          <p:cNvSpPr/>
          <p:nvPr/>
        </p:nvSpPr>
        <p:spPr>
          <a:xfrm>
            <a:off x="7283153" y="3896764"/>
            <a:ext cx="1771277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Internal Sexual Violence Reports/ Investigations Reports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5E179F6-1A1F-41EA-F91F-DF06863A9CF8}"/>
              </a:ext>
            </a:extLst>
          </p:cNvPr>
          <p:cNvSpPr txBox="1"/>
          <p:nvPr/>
        </p:nvSpPr>
        <p:spPr>
          <a:xfrm flipH="1">
            <a:off x="9077221" y="5051830"/>
            <a:ext cx="23837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public/external spher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42DDB89-FCC5-54F5-2137-78FE7C65053A}"/>
              </a:ext>
            </a:extLst>
          </p:cNvPr>
          <p:cNvSpPr txBox="1"/>
          <p:nvPr/>
        </p:nvSpPr>
        <p:spPr>
          <a:xfrm flipH="1">
            <a:off x="8909064" y="4540546"/>
            <a:ext cx="1797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*private/internal sphere 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8814A0CC-6789-17F0-D190-023E5DAC2C9F}"/>
              </a:ext>
            </a:extLst>
          </p:cNvPr>
          <p:cNvSpPr/>
          <p:nvPr/>
        </p:nvSpPr>
        <p:spPr>
          <a:xfrm>
            <a:off x="1509280" y="3016252"/>
            <a:ext cx="1018694" cy="970432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Sexual Harassment Working Group</a:t>
            </a:r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75A35CF8-8CE7-A319-A62E-56C9BC3D1726}"/>
              </a:ext>
            </a:extLst>
          </p:cNvPr>
          <p:cNvSpPr/>
          <p:nvPr/>
        </p:nvSpPr>
        <p:spPr>
          <a:xfrm>
            <a:off x="3253366" y="2256334"/>
            <a:ext cx="925033" cy="919206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chemeClr val="tx1"/>
                </a:solidFill>
              </a:rPr>
              <a:t>President’s Office</a:t>
            </a:r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B83E9890-40EE-0FA2-2791-7E5354CAD359}"/>
              </a:ext>
            </a:extLst>
          </p:cNvPr>
          <p:cNvSpPr/>
          <p:nvPr/>
        </p:nvSpPr>
        <p:spPr>
          <a:xfrm>
            <a:off x="8909065" y="2065577"/>
            <a:ext cx="1023946" cy="958977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>
                <a:solidFill>
                  <a:schemeClr val="tx1"/>
                </a:solidFill>
              </a:rPr>
              <a:t>Student Advocacy/</a:t>
            </a:r>
          </a:p>
          <a:p>
            <a:pPr algn="ctr"/>
            <a:r>
              <a:rPr lang="en-US" sz="900" dirty="0">
                <a:solidFill>
                  <a:schemeClr val="tx1"/>
                </a:solidFill>
              </a:rPr>
              <a:t>Union Groups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F10ABBA8-8796-6C2B-D652-763036F113C1}"/>
              </a:ext>
            </a:extLst>
          </p:cNvPr>
          <p:cNvSpPr/>
          <p:nvPr/>
        </p:nvSpPr>
        <p:spPr>
          <a:xfrm>
            <a:off x="9163686" y="3905335"/>
            <a:ext cx="1771277" cy="37950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Review and Recommendations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1E4CA92-AB95-4B24-373F-7944BF8E01E6}"/>
              </a:ext>
            </a:extLst>
          </p:cNvPr>
          <p:cNvCxnSpPr/>
          <p:nvPr/>
        </p:nvCxnSpPr>
        <p:spPr>
          <a:xfrm>
            <a:off x="5357813" y="4730341"/>
            <a:ext cx="192534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A1157267-3F44-2466-AB8E-17750DC0FC57}"/>
              </a:ext>
            </a:extLst>
          </p:cNvPr>
          <p:cNvSpPr txBox="1"/>
          <p:nvPr/>
        </p:nvSpPr>
        <p:spPr>
          <a:xfrm>
            <a:off x="6077634" y="4752525"/>
            <a:ext cx="14259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ime’s Arrow </a:t>
            </a:r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D6A24267-6443-A6FF-1AB1-5246A5F227F1}"/>
              </a:ext>
            </a:extLst>
          </p:cNvPr>
          <p:cNvSpPr/>
          <p:nvPr/>
        </p:nvSpPr>
        <p:spPr>
          <a:xfrm>
            <a:off x="8256961" y="6072086"/>
            <a:ext cx="393549" cy="236222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566B3729-32AE-30C0-9637-5649733C1540}"/>
              </a:ext>
            </a:extLst>
          </p:cNvPr>
          <p:cNvSpPr/>
          <p:nvPr/>
        </p:nvSpPr>
        <p:spPr>
          <a:xfrm>
            <a:off x="8232321" y="6488921"/>
            <a:ext cx="397503" cy="121416"/>
          </a:xfrm>
          <a:prstGeom prst="ellipse">
            <a:avLst/>
          </a:prstGeom>
          <a:solidFill>
            <a:schemeClr val="bg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4B494ECD-CD8D-67D1-A62A-905F3D1C39B7}"/>
              </a:ext>
            </a:extLst>
          </p:cNvPr>
          <p:cNvSpPr/>
          <p:nvPr/>
        </p:nvSpPr>
        <p:spPr>
          <a:xfrm>
            <a:off x="10333498" y="6133150"/>
            <a:ext cx="545912" cy="12141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0AA9941-C725-236E-9205-30B5366BDE48}"/>
              </a:ext>
            </a:extLst>
          </p:cNvPr>
          <p:cNvSpPr/>
          <p:nvPr/>
        </p:nvSpPr>
        <p:spPr>
          <a:xfrm>
            <a:off x="10160750" y="6075639"/>
            <a:ext cx="626298" cy="10373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 </a:t>
            </a:r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24700EAF-CF34-7DD7-7793-2151A80551B9}"/>
              </a:ext>
            </a:extLst>
          </p:cNvPr>
          <p:cNvSpPr/>
          <p:nvPr/>
        </p:nvSpPr>
        <p:spPr>
          <a:xfrm>
            <a:off x="10523715" y="6377065"/>
            <a:ext cx="272956" cy="279671"/>
          </a:xfrm>
          <a:prstGeom prst="ellipse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11773089-9822-F8EB-1CB3-4F158824FB40}"/>
              </a:ext>
            </a:extLst>
          </p:cNvPr>
          <p:cNvSpPr/>
          <p:nvPr/>
        </p:nvSpPr>
        <p:spPr>
          <a:xfrm>
            <a:off x="10095479" y="6012851"/>
            <a:ext cx="545912" cy="13240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dirty="0">
                <a:ln>
                  <a:solidFill>
                    <a:schemeClr val="tx1"/>
                  </a:solidFill>
                </a:ln>
                <a:solidFill>
                  <a:sysClr val="windowText" lastClr="000000"/>
                </a:solidFill>
              </a:rPr>
              <a:t>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414C303-463C-9B99-A284-AA3B521F265B}"/>
              </a:ext>
            </a:extLst>
          </p:cNvPr>
          <p:cNvSpPr txBox="1"/>
          <p:nvPr/>
        </p:nvSpPr>
        <p:spPr>
          <a:xfrm>
            <a:off x="10834771" y="6019530"/>
            <a:ext cx="9332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Institutional Text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EB28DE8-F81B-FB96-A0FF-76556EF9356C}"/>
              </a:ext>
            </a:extLst>
          </p:cNvPr>
          <p:cNvSpPr txBox="1"/>
          <p:nvPr/>
        </p:nvSpPr>
        <p:spPr>
          <a:xfrm>
            <a:off x="10834771" y="6409179"/>
            <a:ext cx="111761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Institutional Actor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41CBC3EC-4B96-CEAA-04CB-F1D33A989641}"/>
              </a:ext>
            </a:extLst>
          </p:cNvPr>
          <p:cNvSpPr txBox="1"/>
          <p:nvPr/>
        </p:nvSpPr>
        <p:spPr>
          <a:xfrm>
            <a:off x="8669560" y="6029529"/>
            <a:ext cx="178897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Sexual Violence Policy Creation Process – Public Spher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B93F9B9-2D56-0C20-5571-8F6A8684ACAA}"/>
              </a:ext>
            </a:extLst>
          </p:cNvPr>
          <p:cNvSpPr txBox="1"/>
          <p:nvPr/>
        </p:nvSpPr>
        <p:spPr>
          <a:xfrm>
            <a:off x="8637796" y="6457459"/>
            <a:ext cx="1820738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/>
              <a:t>Sexual Violence Policy Creation Process</a:t>
            </a:r>
          </a:p>
          <a:p>
            <a:r>
              <a:rPr lang="en-US" sz="800" dirty="0"/>
              <a:t>Internal Sphere 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55" name="Ink 54">
                <a:extLst>
                  <a:ext uri="{FF2B5EF4-FFF2-40B4-BE49-F238E27FC236}">
                    <a16:creationId xmlns:a16="http://schemas.microsoft.com/office/drawing/2014/main" id="{E9C2897C-B621-5303-5300-9EC95B593E2C}"/>
                  </a:ext>
                </a:extLst>
              </p14:cNvPr>
              <p14:cNvContentPartPr/>
              <p14:nvPr/>
            </p14:nvContentPartPr>
            <p14:xfrm>
              <a:off x="1788692" y="2893701"/>
              <a:ext cx="83160" cy="149400"/>
            </p14:xfrm>
          </p:contentPart>
        </mc:Choice>
        <mc:Fallback xmlns="">
          <p:pic>
            <p:nvPicPr>
              <p:cNvPr id="55" name="Ink 54">
                <a:extLst>
                  <a:ext uri="{FF2B5EF4-FFF2-40B4-BE49-F238E27FC236}">
                    <a16:creationId xmlns:a16="http://schemas.microsoft.com/office/drawing/2014/main" id="{E9C2897C-B621-5303-5300-9EC95B593E2C}"/>
                  </a:ext>
                </a:extLst>
              </p:cNvPr>
              <p:cNvPicPr/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779692" y="2885061"/>
                <a:ext cx="100800" cy="1670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4">
            <p14:nvContentPartPr>
              <p14:cNvPr id="56" name="Ink 55">
                <a:extLst>
                  <a:ext uri="{FF2B5EF4-FFF2-40B4-BE49-F238E27FC236}">
                    <a16:creationId xmlns:a16="http://schemas.microsoft.com/office/drawing/2014/main" id="{1A0FF044-01A2-366F-3A10-45192F3842E8}"/>
                  </a:ext>
                </a:extLst>
              </p14:cNvPr>
              <p14:cNvContentPartPr/>
              <p14:nvPr/>
            </p14:nvContentPartPr>
            <p14:xfrm>
              <a:off x="2019452" y="2483301"/>
              <a:ext cx="347760" cy="147600"/>
            </p14:xfrm>
          </p:contentPart>
        </mc:Choice>
        <mc:Fallback xmlns="">
          <p:pic>
            <p:nvPicPr>
              <p:cNvPr id="56" name="Ink 55">
                <a:extLst>
                  <a:ext uri="{FF2B5EF4-FFF2-40B4-BE49-F238E27FC236}">
                    <a16:creationId xmlns:a16="http://schemas.microsoft.com/office/drawing/2014/main" id="{1A0FF044-01A2-366F-3A10-45192F3842E8}"/>
                  </a:ext>
                </a:extLst>
              </p:cNvPr>
              <p:cNvPicPr/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010812" y="2474661"/>
                <a:ext cx="365400" cy="1652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6">
            <p14:nvContentPartPr>
              <p14:cNvPr id="57" name="Ink 56">
                <a:extLst>
                  <a:ext uri="{FF2B5EF4-FFF2-40B4-BE49-F238E27FC236}">
                    <a16:creationId xmlns:a16="http://schemas.microsoft.com/office/drawing/2014/main" id="{09F81959-ADC4-B03D-162D-B436AD1D765C}"/>
                  </a:ext>
                </a:extLst>
              </p14:cNvPr>
              <p14:cNvContentPartPr/>
              <p14:nvPr/>
            </p14:nvContentPartPr>
            <p14:xfrm>
              <a:off x="3131132" y="2581941"/>
              <a:ext cx="135720" cy="27000"/>
            </p14:xfrm>
          </p:contentPart>
        </mc:Choice>
        <mc:Fallback xmlns="">
          <p:pic>
            <p:nvPicPr>
              <p:cNvPr id="57" name="Ink 56">
                <a:extLst>
                  <a:ext uri="{FF2B5EF4-FFF2-40B4-BE49-F238E27FC236}">
                    <a16:creationId xmlns:a16="http://schemas.microsoft.com/office/drawing/2014/main" id="{09F81959-ADC4-B03D-162D-B436AD1D765C}"/>
                  </a:ext>
                </a:extLst>
              </p:cNvPr>
              <p:cNvPicPr/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122492" y="2573301"/>
                <a:ext cx="153360" cy="446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8">
            <p14:nvContentPartPr>
              <p14:cNvPr id="58" name="Ink 57">
                <a:extLst>
                  <a:ext uri="{FF2B5EF4-FFF2-40B4-BE49-F238E27FC236}">
                    <a16:creationId xmlns:a16="http://schemas.microsoft.com/office/drawing/2014/main" id="{45D5F261-3E7F-9218-A0C3-7E7869077E2B}"/>
                  </a:ext>
                </a:extLst>
              </p14:cNvPr>
              <p14:cNvContentPartPr/>
              <p14:nvPr/>
            </p14:nvContentPartPr>
            <p14:xfrm>
              <a:off x="1938092" y="2727021"/>
              <a:ext cx="1322640" cy="44280"/>
            </p14:xfrm>
          </p:contentPart>
        </mc:Choice>
        <mc:Fallback xmlns="">
          <p:pic>
            <p:nvPicPr>
              <p:cNvPr id="58" name="Ink 57">
                <a:extLst>
                  <a:ext uri="{FF2B5EF4-FFF2-40B4-BE49-F238E27FC236}">
                    <a16:creationId xmlns:a16="http://schemas.microsoft.com/office/drawing/2014/main" id="{45D5F261-3E7F-9218-A0C3-7E7869077E2B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929092" y="2718021"/>
                <a:ext cx="1340280" cy="6192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0">
            <p14:nvContentPartPr>
              <p14:cNvPr id="59" name="Ink 58">
                <a:extLst>
                  <a:ext uri="{FF2B5EF4-FFF2-40B4-BE49-F238E27FC236}">
                    <a16:creationId xmlns:a16="http://schemas.microsoft.com/office/drawing/2014/main" id="{93963D4C-677B-F42A-5AB9-8938A3C606EB}"/>
                  </a:ext>
                </a:extLst>
              </p14:cNvPr>
              <p14:cNvContentPartPr/>
              <p14:nvPr/>
            </p14:nvContentPartPr>
            <p14:xfrm>
              <a:off x="5123732" y="2388981"/>
              <a:ext cx="933120" cy="727560"/>
            </p14:xfrm>
          </p:contentPart>
        </mc:Choice>
        <mc:Fallback xmlns="">
          <p:pic>
            <p:nvPicPr>
              <p:cNvPr id="59" name="Ink 58">
                <a:extLst>
                  <a:ext uri="{FF2B5EF4-FFF2-40B4-BE49-F238E27FC236}">
                    <a16:creationId xmlns:a16="http://schemas.microsoft.com/office/drawing/2014/main" id="{93963D4C-677B-F42A-5AB9-8938A3C606EB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5115092" y="2380341"/>
                <a:ext cx="950760" cy="745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2">
            <p14:nvContentPartPr>
              <p14:cNvPr id="60" name="Ink 59">
                <a:extLst>
                  <a:ext uri="{FF2B5EF4-FFF2-40B4-BE49-F238E27FC236}">
                    <a16:creationId xmlns:a16="http://schemas.microsoft.com/office/drawing/2014/main" id="{39177494-6F02-DC27-38C6-0E0EC96077F3}"/>
                  </a:ext>
                </a:extLst>
              </p14:cNvPr>
              <p14:cNvContentPartPr/>
              <p14:nvPr/>
            </p14:nvContentPartPr>
            <p14:xfrm>
              <a:off x="6459332" y="2390421"/>
              <a:ext cx="213840" cy="695520"/>
            </p14:xfrm>
          </p:contentPart>
        </mc:Choice>
        <mc:Fallback xmlns="">
          <p:pic>
            <p:nvPicPr>
              <p:cNvPr id="60" name="Ink 59">
                <a:extLst>
                  <a:ext uri="{FF2B5EF4-FFF2-40B4-BE49-F238E27FC236}">
                    <a16:creationId xmlns:a16="http://schemas.microsoft.com/office/drawing/2014/main" id="{39177494-6F02-DC27-38C6-0E0EC96077F3}"/>
                  </a:ext>
                </a:extLst>
              </p:cNvPr>
              <p:cNvPicPr/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6450332" y="2381421"/>
                <a:ext cx="231480" cy="7131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4">
            <p14:nvContentPartPr>
              <p14:cNvPr id="61" name="Ink 60">
                <a:extLst>
                  <a:ext uri="{FF2B5EF4-FFF2-40B4-BE49-F238E27FC236}">
                    <a16:creationId xmlns:a16="http://schemas.microsoft.com/office/drawing/2014/main" id="{CA567D72-7449-A536-B377-FF7D3705E847}"/>
                  </a:ext>
                </a:extLst>
              </p14:cNvPr>
              <p14:cNvContentPartPr/>
              <p14:nvPr/>
            </p14:nvContentPartPr>
            <p14:xfrm>
              <a:off x="7362572" y="2388621"/>
              <a:ext cx="610200" cy="825120"/>
            </p14:xfrm>
          </p:contentPart>
        </mc:Choice>
        <mc:Fallback xmlns="">
          <p:pic>
            <p:nvPicPr>
              <p:cNvPr id="61" name="Ink 60">
                <a:extLst>
                  <a:ext uri="{FF2B5EF4-FFF2-40B4-BE49-F238E27FC236}">
                    <a16:creationId xmlns:a16="http://schemas.microsoft.com/office/drawing/2014/main" id="{CA567D72-7449-A536-B377-FF7D3705E847}"/>
                  </a:ext>
                </a:extLst>
              </p:cNvPr>
              <p:cNvPicPr/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7353572" y="2379981"/>
                <a:ext cx="627840" cy="8427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6">
            <p14:nvContentPartPr>
              <p14:cNvPr id="62" name="Ink 61">
                <a:extLst>
                  <a:ext uri="{FF2B5EF4-FFF2-40B4-BE49-F238E27FC236}">
                    <a16:creationId xmlns:a16="http://schemas.microsoft.com/office/drawing/2014/main" id="{BF732249-6F89-D838-24C6-72972A5BE84F}"/>
                  </a:ext>
                </a:extLst>
              </p14:cNvPr>
              <p14:cNvContentPartPr/>
              <p14:nvPr/>
            </p14:nvContentPartPr>
            <p14:xfrm>
              <a:off x="7025972" y="4290861"/>
              <a:ext cx="852480" cy="1303560"/>
            </p14:xfrm>
          </p:contentPart>
        </mc:Choice>
        <mc:Fallback xmlns="">
          <p:pic>
            <p:nvPicPr>
              <p:cNvPr id="62" name="Ink 61">
                <a:extLst>
                  <a:ext uri="{FF2B5EF4-FFF2-40B4-BE49-F238E27FC236}">
                    <a16:creationId xmlns:a16="http://schemas.microsoft.com/office/drawing/2014/main" id="{BF732249-6F89-D838-24C6-72972A5BE84F}"/>
                  </a:ext>
                </a:extLst>
              </p:cNvPr>
              <p:cNvPicPr/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7017332" y="4282221"/>
                <a:ext cx="870120" cy="13212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8">
            <p14:nvContentPartPr>
              <p14:cNvPr id="63" name="Ink 62">
                <a:extLst>
                  <a:ext uri="{FF2B5EF4-FFF2-40B4-BE49-F238E27FC236}">
                    <a16:creationId xmlns:a16="http://schemas.microsoft.com/office/drawing/2014/main" id="{137A2B2E-A664-9FC8-28F2-17CECAA01F26}"/>
                  </a:ext>
                </a:extLst>
              </p14:cNvPr>
              <p14:cNvContentPartPr/>
              <p14:nvPr/>
            </p14:nvContentPartPr>
            <p14:xfrm>
              <a:off x="8251772" y="4305261"/>
              <a:ext cx="57600" cy="981360"/>
            </p14:xfrm>
          </p:contentPart>
        </mc:Choice>
        <mc:Fallback xmlns="">
          <p:pic>
            <p:nvPicPr>
              <p:cNvPr id="63" name="Ink 62">
                <a:extLst>
                  <a:ext uri="{FF2B5EF4-FFF2-40B4-BE49-F238E27FC236}">
                    <a16:creationId xmlns:a16="http://schemas.microsoft.com/office/drawing/2014/main" id="{137A2B2E-A664-9FC8-28F2-17CECAA01F26}"/>
                  </a:ext>
                </a:extLst>
              </p:cNvPr>
              <p:cNvPicPr/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8242772" y="4296261"/>
                <a:ext cx="75240" cy="999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0">
            <p14:nvContentPartPr>
              <p14:cNvPr id="64" name="Ink 63">
                <a:extLst>
                  <a:ext uri="{FF2B5EF4-FFF2-40B4-BE49-F238E27FC236}">
                    <a16:creationId xmlns:a16="http://schemas.microsoft.com/office/drawing/2014/main" id="{687368AD-D6B2-5DD5-95FD-04D2546EB812}"/>
                  </a:ext>
                </a:extLst>
              </p14:cNvPr>
              <p14:cNvContentPartPr/>
              <p14:nvPr/>
            </p14:nvContentPartPr>
            <p14:xfrm>
              <a:off x="4101692" y="3003141"/>
              <a:ext cx="75600" cy="143280"/>
            </p14:xfrm>
          </p:contentPart>
        </mc:Choice>
        <mc:Fallback xmlns="">
          <p:pic>
            <p:nvPicPr>
              <p:cNvPr id="64" name="Ink 63">
                <a:extLst>
                  <a:ext uri="{FF2B5EF4-FFF2-40B4-BE49-F238E27FC236}">
                    <a16:creationId xmlns:a16="http://schemas.microsoft.com/office/drawing/2014/main" id="{687368AD-D6B2-5DD5-95FD-04D2546EB812}"/>
                  </a:ext>
                </a:extLst>
              </p:cNvPr>
              <p:cNvPicPr/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4093052" y="2994501"/>
                <a:ext cx="93240" cy="16092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2">
            <p14:nvContentPartPr>
              <p14:cNvPr id="66" name="Ink 65">
                <a:extLst>
                  <a:ext uri="{FF2B5EF4-FFF2-40B4-BE49-F238E27FC236}">
                    <a16:creationId xmlns:a16="http://schemas.microsoft.com/office/drawing/2014/main" id="{5C596DB9-CB83-396A-4FFD-64E0AD50A0CD}"/>
                  </a:ext>
                </a:extLst>
              </p14:cNvPr>
              <p14:cNvContentPartPr/>
              <p14:nvPr/>
            </p14:nvContentPartPr>
            <p14:xfrm>
              <a:off x="2882012" y="3585621"/>
              <a:ext cx="1083600" cy="526680"/>
            </p14:xfrm>
          </p:contentPart>
        </mc:Choice>
        <mc:Fallback xmlns="">
          <p:pic>
            <p:nvPicPr>
              <p:cNvPr id="66" name="Ink 65">
                <a:extLst>
                  <a:ext uri="{FF2B5EF4-FFF2-40B4-BE49-F238E27FC236}">
                    <a16:creationId xmlns:a16="http://schemas.microsoft.com/office/drawing/2014/main" id="{5C596DB9-CB83-396A-4FFD-64E0AD50A0CD}"/>
                  </a:ext>
                </a:extLst>
              </p:cNvPr>
              <p:cNvPicPr/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2873012" y="3576621"/>
                <a:ext cx="1101240" cy="54432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4">
            <p14:nvContentPartPr>
              <p14:cNvPr id="67" name="Ink 66">
                <a:extLst>
                  <a:ext uri="{FF2B5EF4-FFF2-40B4-BE49-F238E27FC236}">
                    <a16:creationId xmlns:a16="http://schemas.microsoft.com/office/drawing/2014/main" id="{10FBB9C2-5A69-CE1F-B9A6-D13977E6A21E}"/>
                  </a:ext>
                </a:extLst>
              </p14:cNvPr>
              <p14:cNvContentPartPr/>
              <p14:nvPr/>
            </p14:nvContentPartPr>
            <p14:xfrm>
              <a:off x="5155412" y="3570141"/>
              <a:ext cx="694080" cy="349200"/>
            </p14:xfrm>
          </p:contentPart>
        </mc:Choice>
        <mc:Fallback xmlns="">
          <p:pic>
            <p:nvPicPr>
              <p:cNvPr id="67" name="Ink 66">
                <a:extLst>
                  <a:ext uri="{FF2B5EF4-FFF2-40B4-BE49-F238E27FC236}">
                    <a16:creationId xmlns:a16="http://schemas.microsoft.com/office/drawing/2014/main" id="{10FBB9C2-5A69-CE1F-B9A6-D13977E6A21E}"/>
                  </a:ext>
                </a:extLst>
              </p:cNvPr>
              <p:cNvPicPr/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5146412" y="3561141"/>
                <a:ext cx="711720" cy="3668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6">
            <p14:nvContentPartPr>
              <p14:cNvPr id="68" name="Ink 67">
                <a:extLst>
                  <a:ext uri="{FF2B5EF4-FFF2-40B4-BE49-F238E27FC236}">
                    <a16:creationId xmlns:a16="http://schemas.microsoft.com/office/drawing/2014/main" id="{8C5660EC-6B50-CE22-8801-14208BB032B7}"/>
                  </a:ext>
                </a:extLst>
              </p14:cNvPr>
              <p14:cNvContentPartPr/>
              <p14:nvPr/>
            </p14:nvContentPartPr>
            <p14:xfrm>
              <a:off x="7151972" y="3587781"/>
              <a:ext cx="681840" cy="354600"/>
            </p14:xfrm>
          </p:contentPart>
        </mc:Choice>
        <mc:Fallback xmlns="">
          <p:pic>
            <p:nvPicPr>
              <p:cNvPr id="68" name="Ink 67">
                <a:extLst>
                  <a:ext uri="{FF2B5EF4-FFF2-40B4-BE49-F238E27FC236}">
                    <a16:creationId xmlns:a16="http://schemas.microsoft.com/office/drawing/2014/main" id="{8C5660EC-6B50-CE22-8801-14208BB032B7}"/>
                  </a:ext>
                </a:extLst>
              </p:cNvPr>
              <p:cNvPicPr/>
              <p:nvPr/>
            </p:nvPicPr>
            <p:blipFill>
              <a:blip r:embed="rId27"/>
              <a:stretch>
                <a:fillRect/>
              </a:stretch>
            </p:blipFill>
            <p:spPr>
              <a:xfrm>
                <a:off x="7143332" y="3579141"/>
                <a:ext cx="699480" cy="37224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28">
            <p14:nvContentPartPr>
              <p14:cNvPr id="69" name="Ink 68">
                <a:extLst>
                  <a:ext uri="{FF2B5EF4-FFF2-40B4-BE49-F238E27FC236}">
                    <a16:creationId xmlns:a16="http://schemas.microsoft.com/office/drawing/2014/main" id="{69C462C2-0179-C2AC-114D-3FE770E2B2FB}"/>
                  </a:ext>
                </a:extLst>
              </p14:cNvPr>
              <p14:cNvContentPartPr/>
              <p14:nvPr/>
            </p14:nvContentPartPr>
            <p14:xfrm>
              <a:off x="8543012" y="2853741"/>
              <a:ext cx="480960" cy="398880"/>
            </p14:xfrm>
          </p:contentPart>
        </mc:Choice>
        <mc:Fallback xmlns="">
          <p:pic>
            <p:nvPicPr>
              <p:cNvPr id="69" name="Ink 68">
                <a:extLst>
                  <a:ext uri="{FF2B5EF4-FFF2-40B4-BE49-F238E27FC236}">
                    <a16:creationId xmlns:a16="http://schemas.microsoft.com/office/drawing/2014/main" id="{69C462C2-0179-C2AC-114D-3FE770E2B2FB}"/>
                  </a:ext>
                </a:extLst>
              </p:cNvPr>
              <p:cNvPicPr/>
              <p:nvPr/>
            </p:nvPicPr>
            <p:blipFill>
              <a:blip r:embed="rId29"/>
              <a:stretch>
                <a:fillRect/>
              </a:stretch>
            </p:blipFill>
            <p:spPr>
              <a:xfrm>
                <a:off x="8534372" y="2845101"/>
                <a:ext cx="498600" cy="41652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0">
            <p14:nvContentPartPr>
              <p14:cNvPr id="70" name="Ink 69">
                <a:extLst>
                  <a:ext uri="{FF2B5EF4-FFF2-40B4-BE49-F238E27FC236}">
                    <a16:creationId xmlns:a16="http://schemas.microsoft.com/office/drawing/2014/main" id="{9825617E-8037-9E1B-6814-5D3C48ACD769}"/>
                  </a:ext>
                </a:extLst>
              </p14:cNvPr>
              <p14:cNvContentPartPr/>
              <p14:nvPr/>
            </p14:nvContentPartPr>
            <p14:xfrm>
              <a:off x="8635172" y="3498141"/>
              <a:ext cx="968040" cy="70920"/>
            </p14:xfrm>
          </p:contentPart>
        </mc:Choice>
        <mc:Fallback xmlns="">
          <p:pic>
            <p:nvPicPr>
              <p:cNvPr id="70" name="Ink 69">
                <a:extLst>
                  <a:ext uri="{FF2B5EF4-FFF2-40B4-BE49-F238E27FC236}">
                    <a16:creationId xmlns:a16="http://schemas.microsoft.com/office/drawing/2014/main" id="{9825617E-8037-9E1B-6814-5D3C48ACD769}"/>
                  </a:ext>
                </a:extLst>
              </p:cNvPr>
              <p:cNvPicPr/>
              <p:nvPr/>
            </p:nvPicPr>
            <p:blipFill>
              <a:blip r:embed="rId31"/>
              <a:stretch>
                <a:fillRect/>
              </a:stretch>
            </p:blipFill>
            <p:spPr>
              <a:xfrm>
                <a:off x="8626532" y="3489501"/>
                <a:ext cx="985680" cy="8856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32">
            <p14:nvContentPartPr>
              <p14:cNvPr id="71" name="Ink 70">
                <a:extLst>
                  <a:ext uri="{FF2B5EF4-FFF2-40B4-BE49-F238E27FC236}">
                    <a16:creationId xmlns:a16="http://schemas.microsoft.com/office/drawing/2014/main" id="{2B425E7E-3579-7EB4-EF99-A965D1517E23}"/>
                  </a:ext>
                </a:extLst>
              </p14:cNvPr>
              <p14:cNvContentPartPr/>
              <p14:nvPr/>
            </p14:nvContentPartPr>
            <p14:xfrm>
              <a:off x="8599172" y="3718821"/>
              <a:ext cx="587880" cy="192600"/>
            </p14:xfrm>
          </p:contentPart>
        </mc:Choice>
        <mc:Fallback xmlns="">
          <p:pic>
            <p:nvPicPr>
              <p:cNvPr id="71" name="Ink 70">
                <a:extLst>
                  <a:ext uri="{FF2B5EF4-FFF2-40B4-BE49-F238E27FC236}">
                    <a16:creationId xmlns:a16="http://schemas.microsoft.com/office/drawing/2014/main" id="{2B425E7E-3579-7EB4-EF99-A965D1517E23}"/>
                  </a:ext>
                </a:extLst>
              </p:cNvPr>
              <p:cNvPicPr/>
              <p:nvPr/>
            </p:nvPicPr>
            <p:blipFill>
              <a:blip r:embed="rId33"/>
              <a:stretch>
                <a:fillRect/>
              </a:stretch>
            </p:blipFill>
            <p:spPr>
              <a:xfrm>
                <a:off x="8590172" y="3709821"/>
                <a:ext cx="605520" cy="210240"/>
              </a:xfrm>
              <a:prstGeom prst="rect">
                <a:avLst/>
              </a:prstGeom>
            </p:spPr>
          </p:pic>
        </mc:Fallback>
      </mc:AlternateContent>
      <p:sp>
        <p:nvSpPr>
          <p:cNvPr id="74" name="Right Arrow 73">
            <a:extLst>
              <a:ext uri="{FF2B5EF4-FFF2-40B4-BE49-F238E27FC236}">
                <a16:creationId xmlns:a16="http://schemas.microsoft.com/office/drawing/2014/main" id="{18838F94-E1DB-D7DF-15C9-2C01E00B7F8F}"/>
              </a:ext>
            </a:extLst>
          </p:cNvPr>
          <p:cNvSpPr/>
          <p:nvPr/>
        </p:nvSpPr>
        <p:spPr>
          <a:xfrm>
            <a:off x="2678654" y="3410192"/>
            <a:ext cx="836941" cy="45719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5" name="Right Arrow 74">
            <a:extLst>
              <a:ext uri="{FF2B5EF4-FFF2-40B4-BE49-F238E27FC236}">
                <a16:creationId xmlns:a16="http://schemas.microsoft.com/office/drawing/2014/main" id="{2D081935-90BF-C315-3B71-4242DCCA7BA4}"/>
              </a:ext>
            </a:extLst>
          </p:cNvPr>
          <p:cNvSpPr/>
          <p:nvPr/>
        </p:nvSpPr>
        <p:spPr>
          <a:xfrm>
            <a:off x="4946750" y="3433499"/>
            <a:ext cx="684541" cy="45719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Right Arrow 75">
            <a:extLst>
              <a:ext uri="{FF2B5EF4-FFF2-40B4-BE49-F238E27FC236}">
                <a16:creationId xmlns:a16="http://schemas.microsoft.com/office/drawing/2014/main" id="{D70EBD11-9980-C5F3-E862-9E73A9370E1D}"/>
              </a:ext>
            </a:extLst>
          </p:cNvPr>
          <p:cNvSpPr/>
          <p:nvPr/>
        </p:nvSpPr>
        <p:spPr>
          <a:xfrm>
            <a:off x="6891677" y="3435440"/>
            <a:ext cx="684541" cy="45719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Right Arrow 76">
            <a:extLst>
              <a:ext uri="{FF2B5EF4-FFF2-40B4-BE49-F238E27FC236}">
                <a16:creationId xmlns:a16="http://schemas.microsoft.com/office/drawing/2014/main" id="{79DC057C-E241-8812-0F88-A70A4F9AECB1}"/>
              </a:ext>
            </a:extLst>
          </p:cNvPr>
          <p:cNvSpPr/>
          <p:nvPr/>
        </p:nvSpPr>
        <p:spPr>
          <a:xfrm>
            <a:off x="6056852" y="2135554"/>
            <a:ext cx="285333" cy="45719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Oval 2">
            <a:extLst>
              <a:ext uri="{FF2B5EF4-FFF2-40B4-BE49-F238E27FC236}">
                <a16:creationId xmlns:a16="http://schemas.microsoft.com/office/drawing/2014/main" id="{02FDDB85-A221-400D-8D6F-F49746E7CFB6}"/>
              </a:ext>
            </a:extLst>
          </p:cNvPr>
          <p:cNvSpPr/>
          <p:nvPr/>
        </p:nvSpPr>
        <p:spPr>
          <a:xfrm>
            <a:off x="9977294" y="2181273"/>
            <a:ext cx="819377" cy="793048"/>
          </a:xfrm>
          <a:prstGeom prst="ellipse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900" dirty="0">
                <a:solidFill>
                  <a:schemeClr val="tx1"/>
                </a:solidFill>
              </a:rPr>
              <a:t>Ombuds</a:t>
            </a:r>
          </a:p>
        </p:txBody>
      </p:sp>
    </p:spTree>
    <p:extLst>
      <p:ext uri="{BB962C8B-B14F-4D97-AF65-F5344CB8AC3E}">
        <p14:creationId xmlns:p14="http://schemas.microsoft.com/office/powerpoint/2010/main" val="3570967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20154-D5D7-6BCB-D826-82EC485B21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2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nstitutional Actors Roles and Responsibilities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0CF0FB7-0C0F-571F-A4BF-917ED055DDC5}"/>
              </a:ext>
            </a:extLst>
          </p:cNvPr>
          <p:cNvSpPr/>
          <p:nvPr/>
        </p:nvSpPr>
        <p:spPr>
          <a:xfrm>
            <a:off x="8796338" y="1877219"/>
            <a:ext cx="2557462" cy="42481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Reviews case documents from ERC and investig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Makes recommendations on programs and procedures related to sexual violence campaign and policy to the ERC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Makes recommendations and provides them to the ERC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Reports to the President’s Offi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514817FF-82ED-F902-43E7-D34D9779CA2E}"/>
              </a:ext>
            </a:extLst>
          </p:cNvPr>
          <p:cNvSpPr/>
          <p:nvPr/>
        </p:nvSpPr>
        <p:spPr>
          <a:xfrm>
            <a:off x="9393136" y="1214437"/>
            <a:ext cx="1465363" cy="1356123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Review Committee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775663-A6F7-16EB-A582-741576B1E3D5}"/>
              </a:ext>
            </a:extLst>
          </p:cNvPr>
          <p:cNvSpPr/>
          <p:nvPr/>
        </p:nvSpPr>
        <p:spPr>
          <a:xfrm>
            <a:off x="6137671" y="1877219"/>
            <a:ext cx="2557462" cy="42481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endParaRPr lang="en-US" sz="1000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100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100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100" dirty="0">
              <a:solidFill>
                <a:schemeClr val="tx1"/>
              </a:solidFill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Officers enacts the policy and prevention campaign as written by the Action Tea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Officers receive disclosure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Responds to disclosures from faculty, staff, students 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Responsible for consultation with survivor after a disclosure is mad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May initiate protection services (Sexual Violence Response Team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Initiates and liaises with investigators to gather more information, option to conduct a threat respon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Liaises with the Review Committee &amp; provides documents from investig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Receives Review Committee recommendations and gives them to the appropriate authority of the respondent (e.g. dean of respondent’s faculty, vice-president, university librarian), contacts union if respondent is an employee. 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Reports to the President’s Office</a:t>
            </a:r>
          </a:p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A1C8B6C-1044-CD7B-1B31-4DE9CFC0EA98}"/>
              </a:ext>
            </a:extLst>
          </p:cNvPr>
          <p:cNvSpPr/>
          <p:nvPr/>
        </p:nvSpPr>
        <p:spPr>
          <a:xfrm>
            <a:off x="3506390" y="1877219"/>
            <a:ext cx="2557462" cy="42481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Reviews recommendations from the Task force and takes up recommend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Writes the sexual violence policy and prevention campaig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Consults with stakeholde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Creates ERC &amp; Review Committee role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100" dirty="0">
                <a:solidFill>
                  <a:schemeClr val="tx1"/>
                </a:solidFill>
              </a:rPr>
              <a:t>Reports to the President’s Office</a:t>
            </a:r>
          </a:p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ECC5114C-F652-DE02-8BC3-FCB7BA76C7A8}"/>
              </a:ext>
            </a:extLst>
          </p:cNvPr>
          <p:cNvSpPr/>
          <p:nvPr/>
        </p:nvSpPr>
        <p:spPr>
          <a:xfrm>
            <a:off x="894158" y="1877219"/>
            <a:ext cx="2557462" cy="424815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Investigates the culture of the university by conducting an online student survey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Conducts literature review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Holds open consultation meetings with dean’s  and various service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(e.g. sports, health services, housing, student rights, Equity Rights Centre, campus unions, and violence against women community-based organizations)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Consultations with other Canadian campus sexual violence working group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Commissioning a report from an independent campus sexual violence advocate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Write final report with recommendations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900" dirty="0">
                <a:solidFill>
                  <a:schemeClr val="tx1"/>
                </a:solidFill>
              </a:rPr>
              <a:t>Reports to the President’s Office 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DB1A2D87-EDB8-F50B-93FB-5D6BA0D0C906}"/>
              </a:ext>
            </a:extLst>
          </p:cNvPr>
          <p:cNvSpPr/>
          <p:nvPr/>
        </p:nvSpPr>
        <p:spPr>
          <a:xfrm>
            <a:off x="6761856" y="1183878"/>
            <a:ext cx="1465363" cy="1356122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ERC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DD6F21FB-30EB-08FC-C32C-BDB134245FB1}"/>
              </a:ext>
            </a:extLst>
          </p:cNvPr>
          <p:cNvSpPr/>
          <p:nvPr/>
        </p:nvSpPr>
        <p:spPr>
          <a:xfrm>
            <a:off x="4093219" y="1214438"/>
            <a:ext cx="1461493" cy="1356122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/>
              <a:t>Action Team</a:t>
            </a:r>
          </a:p>
        </p:txBody>
      </p:sp>
      <p:sp>
        <p:nvSpPr>
          <p:cNvPr id="13" name="Content Placeholder 12">
            <a:extLst>
              <a:ext uri="{FF2B5EF4-FFF2-40B4-BE49-F238E27FC236}">
                <a16:creationId xmlns:a16="http://schemas.microsoft.com/office/drawing/2014/main" id="{45B2687E-EA6D-276A-3DD4-FE882B3732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29365" y="1214437"/>
            <a:ext cx="1381723" cy="1325563"/>
          </a:xfrm>
          <a:prstGeom prst="ellipse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>
            <a:normAutofit/>
          </a:bodyPr>
          <a:lstStyle/>
          <a:p>
            <a:pPr marL="0" indent="0" algn="ctr">
              <a:buNone/>
            </a:pPr>
            <a:r>
              <a:rPr lang="en-US" sz="1400" dirty="0"/>
              <a:t>Task Force</a:t>
            </a:r>
          </a:p>
        </p:txBody>
      </p:sp>
    </p:spTree>
    <p:extLst>
      <p:ext uri="{BB962C8B-B14F-4D97-AF65-F5344CB8AC3E}">
        <p14:creationId xmlns:p14="http://schemas.microsoft.com/office/powerpoint/2010/main" val="38103443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71</TotalTime>
  <Words>384</Words>
  <Application>Microsoft Macintosh PowerPoint</Application>
  <PresentationFormat>Widescreen</PresentationFormat>
  <Paragraphs>6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Appendix 1. Mapping Social Relations and Institutional Texts (Turner, 2006)</vt:lpstr>
      <vt:lpstr>Appendix 2. Institutional Actors Roles and Responsibilities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ay Ostridge</dc:creator>
  <cp:lastModifiedBy>Lindsay Ostridge</cp:lastModifiedBy>
  <cp:revision>25</cp:revision>
  <dcterms:created xsi:type="dcterms:W3CDTF">2024-04-17T21:42:17Z</dcterms:created>
  <dcterms:modified xsi:type="dcterms:W3CDTF">2024-05-22T20:53:16Z</dcterms:modified>
</cp:coreProperties>
</file>